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DCD506-A1F7-49D1-9BCB-9ADF5AAA9EA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1BF3BF-D5BC-4A33-8980-D09987361E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D0DED4-B3AD-4082-9DA7-12C327C8B90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EDE477-0423-4404-BB2B-094A221AEF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4EAFCC-B1ED-4B72-9D64-5037D545FD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A499A1-BF97-40C2-9B13-E3DDF522FD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AE8F89-19DD-456D-8FE4-44BE5ABAFC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944C1D-CD3B-4452-93E2-62704F0A9C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85BF58-EBCA-4E97-B455-28C7C733E8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274467-797F-4271-837F-E7C252DB0C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17B310-ECC1-48D3-B475-AEE5337A41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CC6501-92A4-4AA4-8C40-9C19BA25AE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55F969-9009-4D4F-9FFB-4438BB62A52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1303200" y="369720"/>
            <a:ext cx="1609920" cy="2003760"/>
            <a:chOff x="1303200" y="369720"/>
            <a:chExt cx="1609920" cy="2003760"/>
          </a:xfrm>
        </p:grpSpPr>
        <p:pic>
          <p:nvPicPr>
            <p:cNvPr id="42" name="Picture 1" descr=""/>
            <p:cNvPicPr/>
            <p:nvPr/>
          </p:nvPicPr>
          <p:blipFill>
            <a:blip r:embed="rId1"/>
            <a:stretch/>
          </p:blipFill>
          <p:spPr>
            <a:xfrm>
              <a:off x="1349280" y="1571760"/>
              <a:ext cx="832680" cy="2397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43" name="TextBox 21"/>
            <p:cNvSpPr/>
            <p:nvPr/>
          </p:nvSpPr>
          <p:spPr>
            <a:xfrm>
              <a:off x="2147040" y="1555920"/>
              <a:ext cx="766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FITM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4" name="Picture 3" descr=""/>
            <p:cNvPicPr/>
            <p:nvPr/>
          </p:nvPicPr>
          <p:blipFill>
            <a:blip r:embed="rId2"/>
            <a:srcRect l="0" t="7875" r="0" b="14250"/>
            <a:stretch/>
          </p:blipFill>
          <p:spPr>
            <a:xfrm>
              <a:off x="1347480" y="1857600"/>
              <a:ext cx="832680" cy="2761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45" name="TextBox 21"/>
            <p:cNvSpPr/>
            <p:nvPr/>
          </p:nvSpPr>
          <p:spPr>
            <a:xfrm>
              <a:off x="2147040" y="1847880"/>
              <a:ext cx="766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ARP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Box 44"/>
            <p:cNvSpPr/>
            <p:nvPr/>
          </p:nvSpPr>
          <p:spPr>
            <a:xfrm rot="16200000">
              <a:off x="1215000" y="1059480"/>
              <a:ext cx="844920" cy="284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hCon + E</a:t>
              </a:r>
              <a:r>
                <a:rPr b="1" lang="en-US" sz="1100" spc="-1" strike="noStrike" baseline="-25000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45"/>
            <p:cNvSpPr/>
            <p:nvPr/>
          </p:nvSpPr>
          <p:spPr>
            <a:xfrm rot="16200000">
              <a:off x="1397160" y="1060560"/>
              <a:ext cx="874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hIFITM1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Straight Connector 31"/>
            <p:cNvSpPr/>
            <p:nvPr/>
          </p:nvSpPr>
          <p:spPr>
            <a:xfrm>
              <a:off x="1410840" y="593280"/>
              <a:ext cx="7239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58"/>
            <p:cNvSpPr/>
            <p:nvPr/>
          </p:nvSpPr>
          <p:spPr>
            <a:xfrm rot="16200000">
              <a:off x="1153080" y="1216080"/>
              <a:ext cx="561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hCon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59"/>
            <p:cNvSpPr/>
            <p:nvPr/>
          </p:nvSpPr>
          <p:spPr>
            <a:xfrm rot="16200000">
              <a:off x="1503720" y="937440"/>
              <a:ext cx="1087560" cy="284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hIFITM1 + E</a:t>
              </a:r>
              <a:r>
                <a:rPr b="1" lang="en-US" sz="1100" spc="-1" strike="noStrike" baseline="-25000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29"/>
            <p:cNvSpPr/>
            <p:nvPr/>
          </p:nvSpPr>
          <p:spPr>
            <a:xfrm>
              <a:off x="1604880" y="369720"/>
              <a:ext cx="456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72 h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18"/>
            <p:cNvSpPr/>
            <p:nvPr/>
          </p:nvSpPr>
          <p:spPr>
            <a:xfrm>
              <a:off x="2148840" y="2105280"/>
              <a:ext cx="5983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</a:t>
              </a: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actin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3" name="Picture 6" descr=""/>
            <p:cNvPicPr/>
            <p:nvPr/>
          </p:nvPicPr>
          <p:blipFill>
            <a:blip r:embed="rId3"/>
            <a:srcRect l="0" t="10279" r="4032" b="11239"/>
            <a:stretch/>
          </p:blipFill>
          <p:spPr>
            <a:xfrm>
              <a:off x="1347480" y="2173680"/>
              <a:ext cx="831240" cy="1998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sp>
        <p:nvSpPr>
          <p:cNvPr id="54" name="TextBox 5"/>
          <p:cNvSpPr/>
          <p:nvPr/>
        </p:nvSpPr>
        <p:spPr>
          <a:xfrm>
            <a:off x="63360" y="0"/>
            <a:ext cx="70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9"/>
          <p:cNvSpPr/>
          <p:nvPr/>
        </p:nvSpPr>
        <p:spPr>
          <a:xfrm>
            <a:off x="274680" y="444600"/>
            <a:ext cx="34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9"/>
          <p:cNvSpPr/>
          <p:nvPr/>
        </p:nvSpPr>
        <p:spPr>
          <a:xfrm>
            <a:off x="349200" y="4259160"/>
            <a:ext cx="3430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7" name="Group 69"/>
          <p:cNvGrpSpPr/>
          <p:nvPr/>
        </p:nvGrpSpPr>
        <p:grpSpPr>
          <a:xfrm>
            <a:off x="824040" y="4344840"/>
            <a:ext cx="3547800" cy="2522520"/>
            <a:chOff x="824040" y="4344840"/>
            <a:chExt cx="3547800" cy="2522520"/>
          </a:xfrm>
        </p:grpSpPr>
        <p:grpSp>
          <p:nvGrpSpPr>
            <p:cNvPr id="58" name="Group 19"/>
            <p:cNvGrpSpPr/>
            <p:nvPr/>
          </p:nvGrpSpPr>
          <p:grpSpPr>
            <a:xfrm>
              <a:off x="824040" y="4344840"/>
              <a:ext cx="3547800" cy="1777680"/>
              <a:chOff x="824040" y="4344840"/>
              <a:chExt cx="3547800" cy="1777680"/>
            </a:xfrm>
          </p:grpSpPr>
          <p:pic>
            <p:nvPicPr>
              <p:cNvPr id="59" name="Chart 3" descr=""/>
              <p:cNvPicPr/>
              <p:nvPr/>
            </p:nvPicPr>
            <p:blipFill>
              <a:blip r:embed="rId4"/>
              <a:stretch/>
            </p:blipFill>
            <p:spPr>
              <a:xfrm>
                <a:off x="824040" y="4344840"/>
                <a:ext cx="3547800" cy="1777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0" name="TextBox 5"/>
              <p:cNvSpPr/>
              <p:nvPr/>
            </p:nvSpPr>
            <p:spPr>
              <a:xfrm rot="16200000">
                <a:off x="1822680" y="5386320"/>
                <a:ext cx="351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ffffff"/>
                    </a:solidFill>
                    <a:latin typeface="Arial"/>
                  </a:rPr>
                  <a:t>61.5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" name="TextBox 6"/>
              <p:cNvSpPr/>
              <p:nvPr/>
            </p:nvSpPr>
            <p:spPr>
              <a:xfrm rot="16200000">
                <a:off x="1351800" y="5386320"/>
                <a:ext cx="351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ffffff"/>
                    </a:solidFill>
                    <a:latin typeface="Arial"/>
                  </a:rPr>
                  <a:t>81.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TextBox 7"/>
              <p:cNvSpPr/>
              <p:nvPr/>
            </p:nvSpPr>
            <p:spPr>
              <a:xfrm rot="16200000">
                <a:off x="2265480" y="5386320"/>
                <a:ext cx="351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ffffff"/>
                    </a:solidFill>
                    <a:latin typeface="Arial"/>
                  </a:rPr>
                  <a:t>67.1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TextBox 8"/>
              <p:cNvSpPr/>
              <p:nvPr/>
            </p:nvSpPr>
            <p:spPr>
              <a:xfrm rot="16200000">
                <a:off x="2694240" y="5393160"/>
                <a:ext cx="351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ffffff"/>
                    </a:solidFill>
                    <a:latin typeface="Arial"/>
                  </a:rPr>
                  <a:t>57.9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TextBox 9"/>
              <p:cNvSpPr/>
              <p:nvPr/>
            </p:nvSpPr>
            <p:spPr>
              <a:xfrm rot="16200000">
                <a:off x="1838880" y="4815720"/>
                <a:ext cx="351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</a:rPr>
                  <a:t>18.7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TextBox 10"/>
              <p:cNvSpPr/>
              <p:nvPr/>
            </p:nvSpPr>
            <p:spPr>
              <a:xfrm rot="16200000">
                <a:off x="2267640" y="4795920"/>
                <a:ext cx="351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</a:rPr>
                  <a:t>12.9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TextBox 11"/>
              <p:cNvSpPr/>
              <p:nvPr/>
            </p:nvSpPr>
            <p:spPr>
              <a:xfrm rot="16200000">
                <a:off x="2703240" y="4944960"/>
                <a:ext cx="351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</a:rPr>
                  <a:t>10.9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" name="TextBox 12"/>
              <p:cNvSpPr/>
              <p:nvPr/>
            </p:nvSpPr>
            <p:spPr>
              <a:xfrm rot="16200000">
                <a:off x="1838880" y="4592880"/>
                <a:ext cx="351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</a:rPr>
                  <a:t>14.5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TextBox 13"/>
              <p:cNvSpPr/>
              <p:nvPr/>
            </p:nvSpPr>
            <p:spPr>
              <a:xfrm rot="16200000">
                <a:off x="2267640" y="4585680"/>
                <a:ext cx="351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</a:rPr>
                  <a:t>14.7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TextBox 14"/>
              <p:cNvSpPr/>
              <p:nvPr/>
            </p:nvSpPr>
            <p:spPr>
              <a:xfrm rot="16200000">
                <a:off x="2696400" y="4686480"/>
                <a:ext cx="351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</a:rPr>
                  <a:t>21.1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0" name="TextBox 44"/>
            <p:cNvSpPr/>
            <p:nvPr/>
          </p:nvSpPr>
          <p:spPr>
            <a:xfrm rot="18868800">
              <a:off x="1386720" y="6134400"/>
              <a:ext cx="844920" cy="284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hCon + E</a:t>
              </a:r>
              <a:r>
                <a:rPr b="1" lang="en-US" sz="1100" spc="-1" strike="noStrike" baseline="-25000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45"/>
            <p:cNvSpPr/>
            <p:nvPr/>
          </p:nvSpPr>
          <p:spPr>
            <a:xfrm rot="18868800">
              <a:off x="1794240" y="6168240"/>
              <a:ext cx="874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hIFITM1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58"/>
            <p:cNvSpPr/>
            <p:nvPr/>
          </p:nvSpPr>
          <p:spPr>
            <a:xfrm rot="18868800">
              <a:off x="1139040" y="6037200"/>
              <a:ext cx="561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hCon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59"/>
            <p:cNvSpPr/>
            <p:nvPr/>
          </p:nvSpPr>
          <p:spPr>
            <a:xfrm rot="18868800">
              <a:off x="2058480" y="6237360"/>
              <a:ext cx="1087560" cy="284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hIFITM1 + E</a:t>
              </a:r>
              <a:r>
                <a:rPr b="1" lang="en-US" sz="1100" spc="-1" strike="noStrike" baseline="-25000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4" name="Group 2"/>
          <p:cNvGrpSpPr/>
          <p:nvPr/>
        </p:nvGrpSpPr>
        <p:grpSpPr>
          <a:xfrm>
            <a:off x="3452760" y="433440"/>
            <a:ext cx="2800440" cy="2770200"/>
            <a:chOff x="3452760" y="433440"/>
            <a:chExt cx="2800440" cy="2770200"/>
          </a:xfrm>
        </p:grpSpPr>
        <p:pic>
          <p:nvPicPr>
            <p:cNvPr id="75" name="Chart 47" descr=""/>
            <p:cNvPicPr/>
            <p:nvPr/>
          </p:nvPicPr>
          <p:blipFill>
            <a:blip r:embed="rId5"/>
            <a:stretch/>
          </p:blipFill>
          <p:spPr>
            <a:xfrm>
              <a:off x="4041360" y="658080"/>
              <a:ext cx="2211840" cy="25455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76" name="Group 63"/>
            <p:cNvGrpSpPr/>
            <p:nvPr/>
          </p:nvGrpSpPr>
          <p:grpSpPr>
            <a:xfrm>
              <a:off x="4743000" y="479160"/>
              <a:ext cx="1291320" cy="1178280"/>
              <a:chOff x="4743000" y="479160"/>
              <a:chExt cx="1291320" cy="1178280"/>
            </a:xfrm>
          </p:grpSpPr>
          <p:sp>
            <p:nvSpPr>
              <p:cNvPr id="77" name="Straight Connector 72"/>
              <p:cNvSpPr/>
              <p:nvPr/>
            </p:nvSpPr>
            <p:spPr>
              <a:xfrm>
                <a:off x="4752360" y="753480"/>
                <a:ext cx="0" cy="1551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" name="Straight Connector 75"/>
              <p:cNvSpPr/>
              <p:nvPr/>
            </p:nvSpPr>
            <p:spPr>
              <a:xfrm>
                <a:off x="5147280" y="762840"/>
                <a:ext cx="0" cy="364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" name="Line 84"/>
              <p:cNvSpPr/>
              <p:nvPr/>
            </p:nvSpPr>
            <p:spPr>
              <a:xfrm>
                <a:off x="4743000" y="754920"/>
                <a:ext cx="4147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" name="Straight Connector 41"/>
              <p:cNvSpPr/>
              <p:nvPr/>
            </p:nvSpPr>
            <p:spPr>
              <a:xfrm>
                <a:off x="4752360" y="488520"/>
                <a:ext cx="0" cy="231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Straight Connector 42"/>
              <p:cNvSpPr/>
              <p:nvPr/>
            </p:nvSpPr>
            <p:spPr>
              <a:xfrm>
                <a:off x="5542560" y="479160"/>
                <a:ext cx="1440" cy="5342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Line 89"/>
              <p:cNvSpPr/>
              <p:nvPr/>
            </p:nvSpPr>
            <p:spPr>
              <a:xfrm>
                <a:off x="4746960" y="491400"/>
                <a:ext cx="7995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Line 92"/>
              <p:cNvSpPr/>
              <p:nvPr/>
            </p:nvSpPr>
            <p:spPr>
              <a:xfrm flipV="1">
                <a:off x="5174280" y="835200"/>
                <a:ext cx="0" cy="291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Line 93"/>
              <p:cNvSpPr/>
              <p:nvPr/>
            </p:nvSpPr>
            <p:spPr>
              <a:xfrm>
                <a:off x="5183640" y="835560"/>
                <a:ext cx="7383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Line 94"/>
              <p:cNvSpPr/>
              <p:nvPr/>
            </p:nvSpPr>
            <p:spPr>
              <a:xfrm>
                <a:off x="5930280" y="828720"/>
                <a:ext cx="0" cy="481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TextBox 56"/>
              <p:cNvSpPr/>
              <p:nvPr/>
            </p:nvSpPr>
            <p:spPr>
              <a:xfrm>
                <a:off x="4982040" y="1038600"/>
                <a:ext cx="397440" cy="338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87" name="Group 58"/>
              <p:cNvGrpSpPr/>
              <p:nvPr/>
            </p:nvGrpSpPr>
            <p:grpSpPr>
              <a:xfrm>
                <a:off x="5379120" y="924840"/>
                <a:ext cx="404280" cy="393840"/>
                <a:chOff x="5379120" y="924840"/>
                <a:chExt cx="404280" cy="393840"/>
              </a:xfrm>
            </p:grpSpPr>
            <p:sp>
              <p:nvSpPr>
                <p:cNvPr id="88" name="TextBox 56"/>
                <p:cNvSpPr/>
                <p:nvPr/>
              </p:nvSpPr>
              <p:spPr>
                <a:xfrm>
                  <a:off x="5385600" y="981360"/>
                  <a:ext cx="39780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*</a:t>
                  </a:r>
                  <a:endParaRPr b="0" lang="en-US" sz="1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9" name="TextBox 56"/>
                <p:cNvSpPr/>
                <p:nvPr/>
              </p:nvSpPr>
              <p:spPr>
                <a:xfrm>
                  <a:off x="5379120" y="924840"/>
                  <a:ext cx="397800" cy="338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90" name="Group 62"/>
              <p:cNvGrpSpPr/>
              <p:nvPr/>
            </p:nvGrpSpPr>
            <p:grpSpPr>
              <a:xfrm>
                <a:off x="5783400" y="1331640"/>
                <a:ext cx="250920" cy="325800"/>
                <a:chOff x="5783400" y="1331640"/>
                <a:chExt cx="250920" cy="325800"/>
              </a:xfrm>
            </p:grpSpPr>
            <p:sp>
              <p:nvSpPr>
                <p:cNvPr id="91" name="TextBox 57"/>
                <p:cNvSpPr/>
                <p:nvPr/>
              </p:nvSpPr>
              <p:spPr>
                <a:xfrm>
                  <a:off x="5783400" y="1331640"/>
                  <a:ext cx="2509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#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" name="TextBox 57"/>
                <p:cNvSpPr/>
                <p:nvPr/>
              </p:nvSpPr>
              <p:spPr>
                <a:xfrm>
                  <a:off x="5788800" y="1396080"/>
                  <a:ext cx="1846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93" name="TextBox 56"/>
            <p:cNvSpPr/>
            <p:nvPr/>
          </p:nvSpPr>
          <p:spPr>
            <a:xfrm>
              <a:off x="4987440" y="1128240"/>
              <a:ext cx="396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TextBox 19"/>
            <p:cNvSpPr/>
            <p:nvPr/>
          </p:nvSpPr>
          <p:spPr>
            <a:xfrm>
              <a:off x="3452760" y="433440"/>
              <a:ext cx="3427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TextBox 114"/>
            <p:cNvSpPr/>
            <p:nvPr/>
          </p:nvSpPr>
          <p:spPr>
            <a:xfrm rot="16200000">
              <a:off x="3263400" y="1446120"/>
              <a:ext cx="13100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ell proliferatio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% of control)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6" name="TextBox 63"/>
          <p:cNvSpPr/>
          <p:nvPr/>
        </p:nvSpPr>
        <p:spPr>
          <a:xfrm rot="16200000">
            <a:off x="261000" y="4771800"/>
            <a:ext cx="1157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% of cell deat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Rectangle 65"/>
          <p:cNvSpPr/>
          <p:nvPr/>
        </p:nvSpPr>
        <p:spPr>
          <a:xfrm flipH="1">
            <a:off x="284040" y="6657120"/>
            <a:ext cx="6289920" cy="228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Figure S4 IFITM1 knockdown increases cell death in AI-resistant breast cancer cells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(a, top panel) MCF-7:5C cells were transfected with control shRNA (shCon), IFITM1 shRNA (shIFITM1) for 24 h and then treated with 1 nM E2 for an additional 72 h. Cell extracts were subject to Western blotting for the level of IFITM1 and PARP protein (top panel). Membranes were also stripped and reprobed for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맑은 고딕"/>
              </a:rPr>
              <a:t>β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-actin, which was used as a loading control. (a, bottom panel) shIFITM1 mRNA level in resistant MCF-7:5C cells was determined by real-time PCR and normalized to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UM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. *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&lt; 0.05 versus shcontrol (shCon). (b) Cell proliferation was measured in resistant MCF-7:5C cells by MTT assay. All the illustrated data were performed in triplicate and are expressed as mean values of three independent experiments. Standard deviations are shown. *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&lt; 0.05 versus control; 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#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&lt; 0.05 versus E2 treatment. (c) MCF-7:5C cells were transfected with shCon or shIFITM1 and after 24 h were exposed to E2 (1 nM) for an additional 72 h. Cells were then stained with annexin V-FITC and PI for detection of apoptosis as described in Materials and Method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56"/>
          <p:cNvSpPr/>
          <p:nvPr/>
        </p:nvSpPr>
        <p:spPr>
          <a:xfrm>
            <a:off x="5894640" y="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oi et al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9" name="Group 4"/>
          <p:cNvGrpSpPr/>
          <p:nvPr/>
        </p:nvGrpSpPr>
        <p:grpSpPr>
          <a:xfrm>
            <a:off x="682560" y="2439720"/>
            <a:ext cx="2205000" cy="1508400"/>
            <a:chOff x="682560" y="2439720"/>
            <a:chExt cx="2205000" cy="1508400"/>
          </a:xfrm>
        </p:grpSpPr>
        <p:pic>
          <p:nvPicPr>
            <p:cNvPr id="100" name="Chart 57" descr=""/>
            <p:cNvPicPr/>
            <p:nvPr/>
          </p:nvPicPr>
          <p:blipFill>
            <a:blip r:embed="rId6"/>
            <a:stretch/>
          </p:blipFill>
          <p:spPr>
            <a:xfrm>
              <a:off x="1005480" y="2480760"/>
              <a:ext cx="1882080" cy="1467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1" name="TextBox 119"/>
            <p:cNvSpPr/>
            <p:nvPr/>
          </p:nvSpPr>
          <p:spPr>
            <a:xfrm>
              <a:off x="2199240" y="2988360"/>
              <a:ext cx="384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TextBox 61"/>
            <p:cNvSpPr/>
            <p:nvPr/>
          </p:nvSpPr>
          <p:spPr>
            <a:xfrm rot="16200000">
              <a:off x="228240" y="2894040"/>
              <a:ext cx="13071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FITM1</a:t>
              </a: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mRNA leve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relative to 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UM1</a:t>
              </a: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)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0-08T22:58:57Z</dcterms:created>
  <dc:creator>Windows User</dc:creator>
  <dc:description/>
  <dc:language>en-US</dc:language>
  <cp:lastModifiedBy>Windows User</cp:lastModifiedBy>
  <dcterms:modified xsi:type="dcterms:W3CDTF">2014-10-08T22:59:23Z</dcterms:modified>
  <cp:revision>1</cp:revision>
  <dc:subject/>
  <dc:title>PowerPoint Presentation</dc:title>
</cp:coreProperties>
</file>